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02" d="100"/>
          <a:sy n="102" d="100"/>
        </p:scale>
        <p:origin x="114" y="3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425A3C-CF6B-4F3E-A907-06436FE40766}" type="datetimeFigureOut">
              <a:rPr lang="en-US" smtClean="0"/>
              <a:t>01/0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D2CEE4-3011-4D21-BD92-CC2F6AD3BB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16716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425A3C-CF6B-4F3E-A907-06436FE40766}" type="datetimeFigureOut">
              <a:rPr lang="en-US" smtClean="0"/>
              <a:t>01/0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D2CEE4-3011-4D21-BD92-CC2F6AD3BB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09634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425A3C-CF6B-4F3E-A907-06436FE40766}" type="datetimeFigureOut">
              <a:rPr lang="en-US" smtClean="0"/>
              <a:t>01/0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D2CEE4-3011-4D21-BD92-CC2F6AD3BB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74022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425A3C-CF6B-4F3E-A907-06436FE40766}" type="datetimeFigureOut">
              <a:rPr lang="en-US" smtClean="0"/>
              <a:t>01/0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D2CEE4-3011-4D21-BD92-CC2F6AD3BB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8271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425A3C-CF6B-4F3E-A907-06436FE40766}" type="datetimeFigureOut">
              <a:rPr lang="en-US" smtClean="0"/>
              <a:t>01/0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D2CEE4-3011-4D21-BD92-CC2F6AD3BB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56321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425A3C-CF6B-4F3E-A907-06436FE40766}" type="datetimeFigureOut">
              <a:rPr lang="en-US" smtClean="0"/>
              <a:t>01/03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D2CEE4-3011-4D21-BD92-CC2F6AD3BB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22280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425A3C-CF6B-4F3E-A907-06436FE40766}" type="datetimeFigureOut">
              <a:rPr lang="en-US" smtClean="0"/>
              <a:t>01/03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D2CEE4-3011-4D21-BD92-CC2F6AD3BB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69689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425A3C-CF6B-4F3E-A907-06436FE40766}" type="datetimeFigureOut">
              <a:rPr lang="en-US" smtClean="0"/>
              <a:t>01/03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D2CEE4-3011-4D21-BD92-CC2F6AD3BB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01941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425A3C-CF6B-4F3E-A907-06436FE40766}" type="datetimeFigureOut">
              <a:rPr lang="en-US" smtClean="0"/>
              <a:t>01/03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D2CEE4-3011-4D21-BD92-CC2F6AD3BB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49748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425A3C-CF6B-4F3E-A907-06436FE40766}" type="datetimeFigureOut">
              <a:rPr lang="en-US" smtClean="0"/>
              <a:t>01/03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D2CEE4-3011-4D21-BD92-CC2F6AD3BB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01520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425A3C-CF6B-4F3E-A907-06436FE40766}" type="datetimeFigureOut">
              <a:rPr lang="en-US" smtClean="0"/>
              <a:t>01/03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D2CEE4-3011-4D21-BD92-CC2F6AD3BB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95597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425A3C-CF6B-4F3E-A907-06436FE40766}" type="datetimeFigureOut">
              <a:rPr lang="en-US" smtClean="0"/>
              <a:t>01/0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D2CEE4-3011-4D21-BD92-CC2F6AD3BB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67753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6" name="Picture 35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1121" y="695765"/>
            <a:ext cx="4927292" cy="3610764"/>
          </a:xfrm>
          <a:prstGeom prst="rect">
            <a:avLst/>
          </a:prstGeom>
          <a:noFill/>
          <a:ln>
            <a:noFill/>
          </a:ln>
        </p:spPr>
      </p:pic>
      <p:sp>
        <p:nvSpPr>
          <p:cNvPr id="2" name="Rectangle 1"/>
          <p:cNvSpPr/>
          <p:nvPr/>
        </p:nvSpPr>
        <p:spPr>
          <a:xfrm>
            <a:off x="294424" y="5054612"/>
            <a:ext cx="10706656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data </a:t>
            </a:r>
            <a:r>
              <a:rPr lang="en-US" sz="14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6. </a:t>
            </a:r>
            <a:r>
              <a:rPr lang="en-US" sz="14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rrelation between survival to oxidative stresses or adhesion capability and the recurrence profile of the strains.</a:t>
            </a:r>
            <a:r>
              <a:rPr lang="en-US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</a:p>
          <a:p>
            <a:pPr algn="just"/>
            <a:r>
              <a:rPr lang="en-US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A) Absence 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f correlation between </a:t>
            </a:r>
            <a:r>
              <a:rPr lang="en-US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rvival to H</a:t>
            </a:r>
            <a:r>
              <a:rPr lang="en-US" sz="1400" baseline="-250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US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</a:t>
            </a:r>
            <a:r>
              <a:rPr lang="en-US" sz="1400" baseline="-250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US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≥ 0.25 mM) </a:t>
            </a:r>
            <a:r>
              <a:rPr lang="en-US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nd 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e recurrence profile of the strains. </a:t>
            </a:r>
            <a:r>
              <a:rPr lang="en-US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e same trend was observed for PQ. (B) Correlation between adhesion capability and the recurrence of the strains. The same trend was observed for biofilm formation. </a:t>
            </a:r>
            <a:endParaRPr lang="en-US" sz="14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37" name="ZoneTexte 1">
            <a:extLst>
              <a:ext uri="{FF2B5EF4-FFF2-40B4-BE49-F238E27FC236}">
                <a16:creationId xmlns:a16="http://schemas.microsoft.com/office/drawing/2014/main" id="{A20CE350-F2F7-4D7C-BD42-D8C13F99E994}"/>
              </a:ext>
            </a:extLst>
          </p:cNvPr>
          <p:cNvSpPr txBox="1"/>
          <p:nvPr/>
        </p:nvSpPr>
        <p:spPr>
          <a:xfrm>
            <a:off x="820654" y="4147013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747946" y="695765"/>
            <a:ext cx="5106867" cy="3610764"/>
          </a:xfrm>
          <a:prstGeom prst="rect">
            <a:avLst/>
          </a:prstGeom>
        </p:spPr>
      </p:pic>
      <p:sp>
        <p:nvSpPr>
          <p:cNvPr id="52" name="ZoneTexte 2">
            <a:extLst>
              <a:ext uri="{FF2B5EF4-FFF2-40B4-BE49-F238E27FC236}">
                <a16:creationId xmlns:a16="http://schemas.microsoft.com/office/drawing/2014/main" id="{41C3B8DF-5010-4094-839A-98A8CCF7A33E}"/>
              </a:ext>
            </a:extLst>
          </p:cNvPr>
          <p:cNvSpPr txBox="1"/>
          <p:nvPr/>
        </p:nvSpPr>
        <p:spPr>
          <a:xfrm>
            <a:off x="6023793" y="4147013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68293347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7</Words>
  <Application>Microsoft Office PowerPoint</Application>
  <PresentationFormat>Widescreen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CTI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organe Nennig</dc:creator>
  <cp:lastModifiedBy>Morgane Nennig</cp:lastModifiedBy>
  <cp:revision>5</cp:revision>
  <dcterms:created xsi:type="dcterms:W3CDTF">2022-02-21T13:56:45Z</dcterms:created>
  <dcterms:modified xsi:type="dcterms:W3CDTF">2022-03-01T06:57:11Z</dcterms:modified>
</cp:coreProperties>
</file>